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792"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9A31393F-5709-4AD2-BAB9-1BE7C507B629}"/>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D0C1ADA0-A89E-4B50-91FF-969A5DC016B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1172E7F0-B4EA-463D-A338-E1015DE81053}"/>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32A4E1C4-24C3-4F00-B6C7-AECE557657E2}"/>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D242D66-A4D1-499F-B1BB-A68CF3DA5488}"/>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1765888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729DC8E2-DF2B-4C71-9BD2-302BD16CC45D}"/>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59CAC998-1E3A-4091-B4B7-98EE36963CCD}"/>
              </a:ext>
            </a:extLst>
          </p:cNvPr>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5FAD3EC1-9A13-4460-B5D9-80EA939A1154}"/>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C7130D93-ED3C-4254-B282-3EE5A83B02F4}"/>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D7BE98C3-0BEE-4DD1-BDD4-9E60ED7B5752}"/>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24388958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AB4A4413-70DE-4076-82F0-FF881DF8B38D}"/>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2B994DBA-14FE-4B83-96C4-1FFBF4213EC9}"/>
              </a:ext>
            </a:extLst>
          </p:cNvPr>
          <p:cNvSpPr>
            <a:spLocks noGrp="1"/>
          </p:cNvSpPr>
          <p:nvPr>
            <p:ph type="body" orient="vert" idx="1"/>
          </p:nvPr>
        </p:nvSpPr>
        <p:spPr>
          <a:xfrm>
            <a:off x="838200" y="365125"/>
            <a:ext cx="7734300" cy="5811838"/>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0D28814E-98CC-451D-96D6-CE1928D4BB87}"/>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F9BB6377-8B53-4367-AC82-768BB16D2B81}"/>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068D5D80-C925-44D6-B948-FF796400F05C}"/>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426842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DB973CF-ABF0-4DC7-B925-43CCD3681A32}"/>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0482D6CF-CC91-48B9-9B19-3184A28E4366}"/>
              </a:ext>
            </a:extLst>
          </p:cNvPr>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0288C7B7-A565-4ADF-8F56-28BEEDB8E346}"/>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30754E2D-846A-4E4B-A691-99215FEAAF01}"/>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AFBBE2D4-B408-495E-8892-AC7A9CF688E3}"/>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26431155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BF2EE1D-94FB-4922-9331-A16C70D1E72F}"/>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04EBEA86-8951-4712-8309-F6F2B6D8704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Fare clic per modificare gli stili del testo dello schema</a:t>
            </a:r>
          </a:p>
        </p:txBody>
      </p:sp>
      <p:sp>
        <p:nvSpPr>
          <p:cNvPr id="4" name="Segnaposto data 3">
            <a:extLst>
              <a:ext uri="{FF2B5EF4-FFF2-40B4-BE49-F238E27FC236}">
                <a16:creationId xmlns:a16="http://schemas.microsoft.com/office/drawing/2014/main" id="{DDED17C6-468A-49BB-8F19-4CAD7848F351}"/>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411DDE34-541F-477C-A50E-6FA3EF9096EF}"/>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0F2D8F2E-249F-4940-AFE8-B1A30F2D49B6}"/>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18388811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18121F94-721F-45F7-891D-70F679B63C6C}"/>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55D7FFF9-CDA7-4A03-A7D7-1C9B221D372B}"/>
              </a:ext>
            </a:extLst>
          </p:cNvPr>
          <p:cNvSpPr>
            <a:spLocks noGrp="1"/>
          </p:cNvSpPr>
          <p:nvPr>
            <p:ph sz="half" idx="1"/>
          </p:nvPr>
        </p:nvSpPr>
        <p:spPr>
          <a:xfrm>
            <a:off x="838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5DBC02E1-1090-4CF6-93E2-D86797437F93}"/>
              </a:ext>
            </a:extLst>
          </p:cNvPr>
          <p:cNvSpPr>
            <a:spLocks noGrp="1"/>
          </p:cNvSpPr>
          <p:nvPr>
            <p:ph sz="half" idx="2"/>
          </p:nvPr>
        </p:nvSpPr>
        <p:spPr>
          <a:xfrm>
            <a:off x="6172200" y="1825625"/>
            <a:ext cx="5181600" cy="435133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86E2C140-F7A5-4DE5-83B0-9EE78CA9E520}"/>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6" name="Segnaposto piè di pagina 5">
            <a:extLst>
              <a:ext uri="{FF2B5EF4-FFF2-40B4-BE49-F238E27FC236}">
                <a16:creationId xmlns:a16="http://schemas.microsoft.com/office/drawing/2014/main" id="{84A0F6D6-B516-47A3-8D59-91C0E81F9599}"/>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AD5CB3CA-10BA-45EF-978D-01D2F8633DCC}"/>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3613132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4AF2D4EA-09FA-4009-B51F-D8D26323B60C}"/>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170ED8BE-F860-47AC-B58D-AC4125E4D0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Segnaposto contenuto 3">
            <a:extLst>
              <a:ext uri="{FF2B5EF4-FFF2-40B4-BE49-F238E27FC236}">
                <a16:creationId xmlns:a16="http://schemas.microsoft.com/office/drawing/2014/main" id="{3AEC240E-49BC-4277-99AB-77F3D3BDC04F}"/>
              </a:ext>
            </a:extLst>
          </p:cNvPr>
          <p:cNvSpPr>
            <a:spLocks noGrp="1"/>
          </p:cNvSpPr>
          <p:nvPr>
            <p:ph sz="half" idx="2"/>
          </p:nvPr>
        </p:nvSpPr>
        <p:spPr>
          <a:xfrm>
            <a:off x="839788" y="2505075"/>
            <a:ext cx="5157787"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F0439224-1608-42A0-9431-AF6E11FE041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Segnaposto contenuto 5">
            <a:extLst>
              <a:ext uri="{FF2B5EF4-FFF2-40B4-BE49-F238E27FC236}">
                <a16:creationId xmlns:a16="http://schemas.microsoft.com/office/drawing/2014/main" id="{262AB3BB-E7AF-4C00-914A-B94F7851D513}"/>
              </a:ext>
            </a:extLst>
          </p:cNvPr>
          <p:cNvSpPr>
            <a:spLocks noGrp="1"/>
          </p:cNvSpPr>
          <p:nvPr>
            <p:ph sz="quarter" idx="4"/>
          </p:nvPr>
        </p:nvSpPr>
        <p:spPr>
          <a:xfrm>
            <a:off x="6172200" y="2505075"/>
            <a:ext cx="5183188" cy="3684588"/>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D90B944D-F13B-4D1F-B19E-9B2B77D20F68}"/>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8" name="Segnaposto piè di pagina 7">
            <a:extLst>
              <a:ext uri="{FF2B5EF4-FFF2-40B4-BE49-F238E27FC236}">
                <a16:creationId xmlns:a16="http://schemas.microsoft.com/office/drawing/2014/main" id="{EEB929D7-BD30-4043-9434-39F6492D8177}"/>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2D16814C-38CA-4455-AB38-9FD9AD95A88F}"/>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39907382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0BDF2DCC-E76B-435D-8B48-43F93AFE0E26}"/>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A90DEB58-3198-47E9-9018-E9511FC4638E}"/>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4" name="Segnaposto piè di pagina 3">
            <a:extLst>
              <a:ext uri="{FF2B5EF4-FFF2-40B4-BE49-F238E27FC236}">
                <a16:creationId xmlns:a16="http://schemas.microsoft.com/office/drawing/2014/main" id="{DCA0D478-124B-4B48-A504-DCCA8F0C31C5}"/>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1D1B6430-8321-4F2D-8988-A80131C8E330}"/>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813860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4EEDB270-DF9C-45E7-BE86-9D10F22D3040}"/>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3" name="Segnaposto piè di pagina 2">
            <a:extLst>
              <a:ext uri="{FF2B5EF4-FFF2-40B4-BE49-F238E27FC236}">
                <a16:creationId xmlns:a16="http://schemas.microsoft.com/office/drawing/2014/main" id="{F41BAFEC-959D-46A6-AA6A-6558ED84C499}"/>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2FCCA2B1-AC40-4CFE-B50F-F6C3EDE2A374}"/>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18833976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9B0A7EC-B2E9-4871-B1C4-0AD5653D438D}"/>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AC21B16A-5607-4D2D-B4CE-92ACDC0B466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366876A9-65B7-44F4-BE2B-629392D329B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5F778E70-CD40-4725-9A0C-4C34B4D512A2}"/>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6" name="Segnaposto piè di pagina 5">
            <a:extLst>
              <a:ext uri="{FF2B5EF4-FFF2-40B4-BE49-F238E27FC236}">
                <a16:creationId xmlns:a16="http://schemas.microsoft.com/office/drawing/2014/main" id="{68E8084F-B9ED-4313-AAAF-3BA342533A9D}"/>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8CE4AF21-C02C-4E7A-808D-88082D768078}"/>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2024918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936F8A7-6BC4-4F27-9974-41CE5508C28E}"/>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86328D4B-75A5-4CA4-9166-DD75C0A7ACE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59C0110F-8A11-4C81-9A84-1205A37311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Fare clic per modificare gli stili del testo dello schema</a:t>
            </a:r>
          </a:p>
        </p:txBody>
      </p:sp>
      <p:sp>
        <p:nvSpPr>
          <p:cNvPr id="5" name="Segnaposto data 4">
            <a:extLst>
              <a:ext uri="{FF2B5EF4-FFF2-40B4-BE49-F238E27FC236}">
                <a16:creationId xmlns:a16="http://schemas.microsoft.com/office/drawing/2014/main" id="{C6FDC1BD-9E29-4337-A5A6-18ACE22969EB}"/>
              </a:ext>
            </a:extLst>
          </p:cNvPr>
          <p:cNvSpPr>
            <a:spLocks noGrp="1"/>
          </p:cNvSpPr>
          <p:nvPr>
            <p:ph type="dt" sz="half" idx="10"/>
          </p:nvPr>
        </p:nvSpPr>
        <p:spPr/>
        <p:txBody>
          <a:bodyPr/>
          <a:lstStyle/>
          <a:p>
            <a:fld id="{F7EDF417-FDFC-4656-B6BC-FC02AFF79451}" type="datetimeFigureOut">
              <a:rPr lang="it-IT" smtClean="0"/>
              <a:t>06/05/2020</a:t>
            </a:fld>
            <a:endParaRPr lang="it-IT"/>
          </a:p>
        </p:txBody>
      </p:sp>
      <p:sp>
        <p:nvSpPr>
          <p:cNvPr id="6" name="Segnaposto piè di pagina 5">
            <a:extLst>
              <a:ext uri="{FF2B5EF4-FFF2-40B4-BE49-F238E27FC236}">
                <a16:creationId xmlns:a16="http://schemas.microsoft.com/office/drawing/2014/main" id="{F4DAA663-4A48-4D88-AD6E-118E98C0D221}"/>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3064E78E-BF4C-46C8-901A-6F06D5E0D496}"/>
              </a:ext>
            </a:extLst>
          </p:cNvPr>
          <p:cNvSpPr>
            <a:spLocks noGrp="1"/>
          </p:cNvSpPr>
          <p:nvPr>
            <p:ph type="sldNum" sz="quarter" idx="12"/>
          </p:nvPr>
        </p:nvSpPr>
        <p:spPr/>
        <p:txBody>
          <a:bodyPr/>
          <a:lstStyle/>
          <a:p>
            <a:fld id="{48804E38-2889-4A5B-8C67-67D6161D068F}" type="slidenum">
              <a:rPr lang="it-IT" smtClean="0"/>
              <a:t>‹N›</a:t>
            </a:fld>
            <a:endParaRPr lang="it-IT"/>
          </a:p>
        </p:txBody>
      </p:sp>
    </p:spTree>
    <p:extLst>
      <p:ext uri="{BB962C8B-B14F-4D97-AF65-F5344CB8AC3E}">
        <p14:creationId xmlns:p14="http://schemas.microsoft.com/office/powerpoint/2010/main" val="5994536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8B13B47C-E9C8-4A70-822E-D2203974890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57A5BCA3-54B3-4272-B35E-9A40F0E0346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212E48DA-4F5E-46BA-8A10-A1D6B9E62FD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7EDF417-FDFC-4656-B6BC-FC02AFF79451}" type="datetimeFigureOut">
              <a:rPr lang="it-IT" smtClean="0"/>
              <a:t>06/05/2020</a:t>
            </a:fld>
            <a:endParaRPr lang="it-IT"/>
          </a:p>
        </p:txBody>
      </p:sp>
      <p:sp>
        <p:nvSpPr>
          <p:cNvPr id="5" name="Segnaposto piè di pagina 4">
            <a:extLst>
              <a:ext uri="{FF2B5EF4-FFF2-40B4-BE49-F238E27FC236}">
                <a16:creationId xmlns:a16="http://schemas.microsoft.com/office/drawing/2014/main" id="{20B55FF2-953A-4091-A457-E442E519550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196053FA-8540-4147-BE90-B6E0316D068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804E38-2889-4A5B-8C67-67D6161D068F}" type="slidenum">
              <a:rPr lang="it-IT" smtClean="0"/>
              <a:t>‹N›</a:t>
            </a:fld>
            <a:endParaRPr lang="it-IT"/>
          </a:p>
        </p:txBody>
      </p:sp>
    </p:spTree>
    <p:extLst>
      <p:ext uri="{BB962C8B-B14F-4D97-AF65-F5344CB8AC3E}">
        <p14:creationId xmlns:p14="http://schemas.microsoft.com/office/powerpoint/2010/main" val="31457435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descr="Immagine che contiene screenshot&#10;&#10;Descrizione generata automaticamente">
            <a:extLst>
              <a:ext uri="{FF2B5EF4-FFF2-40B4-BE49-F238E27FC236}">
                <a16:creationId xmlns:a16="http://schemas.microsoft.com/office/drawing/2014/main" id="{25AFF2EC-290F-471D-94E6-4425EF6FF9F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08000" y="614797"/>
            <a:ext cx="7776000" cy="6075651"/>
          </a:xfrm>
          <a:prstGeom prst="rect">
            <a:avLst/>
          </a:prstGeom>
        </p:spPr>
      </p:pic>
      <p:sp>
        <p:nvSpPr>
          <p:cNvPr id="4" name="Rettangolo 3">
            <a:extLst>
              <a:ext uri="{FF2B5EF4-FFF2-40B4-BE49-F238E27FC236}">
                <a16:creationId xmlns:a16="http://schemas.microsoft.com/office/drawing/2014/main" id="{4C2BA084-8F54-4C2C-9DAA-39C717CCFC89}"/>
              </a:ext>
            </a:extLst>
          </p:cNvPr>
          <p:cNvSpPr/>
          <p:nvPr/>
        </p:nvSpPr>
        <p:spPr>
          <a:xfrm>
            <a:off x="194603" y="167552"/>
            <a:ext cx="11802794" cy="646331"/>
          </a:xfrm>
          <a:prstGeom prst="rect">
            <a:avLst/>
          </a:prstGeom>
        </p:spPr>
        <p:txBody>
          <a:bodyPr wrap="square">
            <a:spAutoFit/>
          </a:bodyPr>
          <a:lstStyle/>
          <a:p>
            <a:r>
              <a:rPr lang="en-US"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1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Temperature variation observed in the four experimental trials during the growing season. Day (red) and night (blue) maximum temperatures are reported for each field. Dashed lines represent critical threshold of 32°C (red)/26°C (blue) day/night. (C2016 = Campania field in the year 2016; C2017 = Campania field in the year 2017; P2016 = Puglia field in the year 2016; P2017 = Puglia field in the year 2017)</a:t>
            </a:r>
            <a:endParaRPr lang="it-IT"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89734652"/>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TotalTime>
  <Words>92</Words>
  <Application>Microsoft Office PowerPoint</Application>
  <PresentationFormat>Widescreen</PresentationFormat>
  <Paragraphs>1</Paragraphs>
  <Slides>1</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1</vt:i4>
      </vt:variant>
    </vt:vector>
  </HeadingPairs>
  <TitlesOfParts>
    <vt:vector size="6" baseType="lpstr">
      <vt:lpstr>Arial</vt:lpstr>
      <vt:lpstr>Calibri</vt:lpstr>
      <vt:lpstr>Calibri Light</vt:lpstr>
      <vt:lpstr>Times New Roman</vt:lpstr>
      <vt:lpstr>Tema di Office</vt:lpstr>
      <vt:lpstr>Presentazione standard di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Fabrizio Olivieri</dc:creator>
  <cp:lastModifiedBy>Fabrizio Olivieri</cp:lastModifiedBy>
  <cp:revision>2</cp:revision>
  <dcterms:created xsi:type="dcterms:W3CDTF">2020-05-06T12:12:24Z</dcterms:created>
  <dcterms:modified xsi:type="dcterms:W3CDTF">2020-05-06T12:30:56Z</dcterms:modified>
</cp:coreProperties>
</file>